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</p:sldIdLst>
  <p:sldSz cx="9601200" cy="12801600" type="A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ohler, Robin" initials="KR" lastIdx="3" clrIdx="0">
    <p:extLst>
      <p:ext uri="{19B8F6BF-5375-455C-9EA6-DF929625EA0E}">
        <p15:presenceInfo xmlns:p15="http://schemas.microsoft.com/office/powerpoint/2012/main" userId="S-1-5-21-838274382-224547350-620655208-124924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4660"/>
  </p:normalViewPr>
  <p:slideViewPr>
    <p:cSldViewPr snapToGrid="0">
      <p:cViewPr varScale="1">
        <p:scale>
          <a:sx n="56" d="100"/>
          <a:sy n="56" d="100"/>
        </p:scale>
        <p:origin x="229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4997E-8E5D-414C-8EFC-0274D41C5FD2}" type="datetimeFigureOut">
              <a:rPr lang="de-DE" smtClean="0"/>
              <a:t>20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24C181-8CB8-4186-AB54-FBA23B24CD7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967987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4997E-8E5D-414C-8EFC-0274D41C5FD2}" type="datetimeFigureOut">
              <a:rPr lang="de-DE" smtClean="0"/>
              <a:t>20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24C181-8CB8-4186-AB54-FBA23B24CD7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313372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4997E-8E5D-414C-8EFC-0274D41C5FD2}" type="datetimeFigureOut">
              <a:rPr lang="de-DE" smtClean="0"/>
              <a:t>20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24C181-8CB8-4186-AB54-FBA23B24CD7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225901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4997E-8E5D-414C-8EFC-0274D41C5FD2}" type="datetimeFigureOut">
              <a:rPr lang="de-DE" smtClean="0"/>
              <a:t>20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24C181-8CB8-4186-AB54-FBA23B24CD7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62905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4997E-8E5D-414C-8EFC-0274D41C5FD2}" type="datetimeFigureOut">
              <a:rPr lang="de-DE" smtClean="0"/>
              <a:t>20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24C181-8CB8-4186-AB54-FBA23B24CD7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6971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4997E-8E5D-414C-8EFC-0274D41C5FD2}" type="datetimeFigureOut">
              <a:rPr lang="de-DE" smtClean="0"/>
              <a:t>20.01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24C181-8CB8-4186-AB54-FBA23B24CD7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830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4997E-8E5D-414C-8EFC-0274D41C5FD2}" type="datetimeFigureOut">
              <a:rPr lang="de-DE" smtClean="0"/>
              <a:t>20.01.20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24C181-8CB8-4186-AB54-FBA23B24CD7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25782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4997E-8E5D-414C-8EFC-0274D41C5FD2}" type="datetimeFigureOut">
              <a:rPr lang="de-DE" smtClean="0"/>
              <a:t>20.01.20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24C181-8CB8-4186-AB54-FBA23B24CD7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8038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4997E-8E5D-414C-8EFC-0274D41C5FD2}" type="datetimeFigureOut">
              <a:rPr lang="de-DE" smtClean="0"/>
              <a:t>20.01.20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24C181-8CB8-4186-AB54-FBA23B24CD7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300220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4997E-8E5D-414C-8EFC-0274D41C5FD2}" type="datetimeFigureOut">
              <a:rPr lang="de-DE" smtClean="0"/>
              <a:t>20.01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24C181-8CB8-4186-AB54-FBA23B24CD7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15695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4997E-8E5D-414C-8EFC-0274D41C5FD2}" type="datetimeFigureOut">
              <a:rPr lang="de-DE" smtClean="0"/>
              <a:t>20.01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24C181-8CB8-4186-AB54-FBA23B24CD7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059795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D4997E-8E5D-414C-8EFC-0274D41C5FD2}" type="datetimeFigureOut">
              <a:rPr lang="de-DE" smtClean="0"/>
              <a:t>20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24C181-8CB8-4186-AB54-FBA23B24CD7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633938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26441829"/>
              </p:ext>
            </p:extLst>
          </p:nvPr>
        </p:nvGraphicFramePr>
        <p:xfrm>
          <a:off x="6350" y="75988"/>
          <a:ext cx="9585325" cy="1914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10103247" imgH="2013981" progId="Prism10.Document">
                  <p:embed/>
                </p:oleObj>
              </mc:Choice>
              <mc:Fallback>
                <p:oleObj name="Prism 10" r:id="rId2" imgW="10103247" imgH="2013981" progId="Prism10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350" y="75988"/>
                        <a:ext cx="9585325" cy="1914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Rectangle 5">
            <a:extLst>
              <a:ext uri="{FF2B5EF4-FFF2-40B4-BE49-F238E27FC236}">
                <a16:creationId xmlns:a16="http://schemas.microsoft.com/office/drawing/2014/main" id="{F4F0DFA0-4634-2917-49FB-096032F03A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1822329"/>
            <a:ext cx="9601200" cy="9002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/>
            <a:r>
              <a:rPr lang="de-D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</a:t>
            </a:r>
            <a:r>
              <a:rPr lang="de-D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Fig. 1: </a:t>
            </a:r>
            <a:r>
              <a:rPr lang="de-D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vision</a:t>
            </a:r>
            <a:r>
              <a:rPr lang="de-D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de-D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ath</a:t>
            </a:r>
            <a:r>
              <a:rPr lang="de-D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tes</a:t>
            </a:r>
            <a:r>
              <a:rPr lang="de-D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sist</a:t>
            </a:r>
            <a:r>
              <a:rPr lang="de-D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dentification</a:t>
            </a:r>
            <a:r>
              <a:rPr lang="de-D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condary</a:t>
            </a:r>
            <a:r>
              <a:rPr lang="de-D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atment</a:t>
            </a:r>
            <a:r>
              <a:rPr lang="de-D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fects</a:t>
            </a:r>
            <a:r>
              <a:rPr lang="de-D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lculated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owth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MSO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de-D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fter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atment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0</a:t>
            </a:r>
            <a:r>
              <a:rPr lang="de-DE" sz="105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6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 AMG 232 (</a:t>
            </a:r>
            <a:r>
              <a:rPr lang="de-D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10</a:t>
            </a:r>
            <a:r>
              <a:rPr lang="de-DE" sz="105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6.5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 YKL-5-124 (</a:t>
            </a:r>
            <a:r>
              <a:rPr lang="de-D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0</a:t>
            </a:r>
            <a:r>
              <a:rPr lang="de-DE" sz="105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7.5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olasertib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de-D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as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pared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unt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ver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ur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s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fter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atment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ch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dition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onential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owth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rves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DaD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say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ta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lue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ne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ll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unting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ta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ero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ur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ellow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ne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imeframe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DaD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say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ero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wo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rk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een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ne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imeframe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fter </a:t>
            </a:r>
            <a:r>
              <a:rPr lang="de-DE" sz="105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DaD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ssurement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wo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ur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ink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ne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lculated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ast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quare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gression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oted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95%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fidence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erval</a:t>
            </a:r>
            <a:r>
              <a:rPr lang="de-DE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5" name="Textfeld 4"/>
          <p:cNvSpPr txBox="1"/>
          <p:nvPr/>
        </p:nvSpPr>
        <p:spPr>
          <a:xfrm>
            <a:off x="2230214" y="-7535"/>
            <a:ext cx="3007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  <a:endParaRPr lang="de-DE" dirty="0"/>
          </a:p>
        </p:txBody>
      </p:sp>
      <p:sp>
        <p:nvSpPr>
          <p:cNvPr id="6" name="Textfeld 5"/>
          <p:cNvSpPr txBox="1"/>
          <p:nvPr/>
        </p:nvSpPr>
        <p:spPr>
          <a:xfrm>
            <a:off x="4354866" y="-753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  <a:endParaRPr lang="de-DE" dirty="0"/>
          </a:p>
        </p:txBody>
      </p:sp>
      <p:sp>
        <p:nvSpPr>
          <p:cNvPr id="7" name="Textfeld 6"/>
          <p:cNvSpPr txBox="1"/>
          <p:nvPr/>
        </p:nvSpPr>
        <p:spPr>
          <a:xfrm>
            <a:off x="6496500" y="-7535"/>
            <a:ext cx="2897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</a:t>
            </a:r>
            <a:endParaRPr lang="de-DE" dirty="0"/>
          </a:p>
        </p:txBody>
      </p:sp>
      <p:sp>
        <p:nvSpPr>
          <p:cNvPr id="8" name="Textfeld 7"/>
          <p:cNvSpPr txBox="1"/>
          <p:nvPr/>
        </p:nvSpPr>
        <p:spPr>
          <a:xfrm>
            <a:off x="109420" y="-753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2897986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48</Words>
  <Application>Microsoft Office PowerPoint</Application>
  <PresentationFormat>A3-Papier (297 x 420 mm)</PresentationFormat>
  <Paragraphs>5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</vt:lpstr>
      <vt:lpstr>Prism 10</vt:lpstr>
      <vt:lpstr>PowerPoint-Präsentation</vt:lpstr>
    </vt:vector>
  </TitlesOfParts>
  <Company>Universitätsklinikum Leipzig Aö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 novel Combination of cell division and apoptosis tracking in one cell population</dc:title>
  <dc:creator>Kohler, Robin</dc:creator>
  <cp:lastModifiedBy>Kohler, Robin</cp:lastModifiedBy>
  <cp:revision>79</cp:revision>
  <cp:lastPrinted>2024-09-23T13:28:40Z</cp:lastPrinted>
  <dcterms:created xsi:type="dcterms:W3CDTF">2024-05-15T14:51:07Z</dcterms:created>
  <dcterms:modified xsi:type="dcterms:W3CDTF">2025-01-20T13:39:41Z</dcterms:modified>
</cp:coreProperties>
</file>